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sec, Jan" initials="LJ" lastIdx="3" clrIdx="0">
    <p:extLst>
      <p:ext uri="{19B8F6BF-5375-455C-9EA6-DF929625EA0E}">
        <p15:presenceInfo xmlns="" xmlns:p15="http://schemas.microsoft.com/office/powerpoint/2012/main" userId="S-1-5-21-126249482-453980865-1851928258-304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FF3399"/>
    <a:srgbClr val="D60093"/>
    <a:srgbClr val="FF0066"/>
    <a:srgbClr val="FFFFF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6324" autoAdjust="0"/>
    <p:restoredTop sz="84919" autoAdjust="0"/>
  </p:normalViewPr>
  <p:slideViewPr>
    <p:cSldViewPr>
      <p:cViewPr>
        <p:scale>
          <a:sx n="112" d="100"/>
          <a:sy n="112" d="100"/>
        </p:scale>
        <p:origin x="-960" y="19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89"/>
          <c:y val="7.3461912890367687E-2"/>
          <c:w val="0.77012891507294867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C SI'!$B$2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0070C0"/>
            </a:solidFill>
            <a:ln w="6350" cap="flat" cmpd="sng" algn="ctr">
              <a:solidFill>
                <a:srgbClr val="0070C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C SI'!$C$3:$G$3</c:f>
                <c:numCache>
                  <c:formatCode>General</c:formatCode>
                  <c:ptCount val="5"/>
                  <c:pt idx="0">
                    <c:v>8.6323493222031835E-3</c:v>
                  </c:pt>
                  <c:pt idx="1">
                    <c:v>0.1212111502976545</c:v>
                  </c:pt>
                  <c:pt idx="2">
                    <c:v>3.7493525670449515E-2</c:v>
                  </c:pt>
                  <c:pt idx="3">
                    <c:v>1.547614904128114E-2</c:v>
                  </c:pt>
                  <c:pt idx="4">
                    <c:v>4.9875310555287114E-2</c:v>
                  </c:pt>
                </c:numCache>
              </c:numRef>
            </c:plus>
            <c:minus>
              <c:numRef>
                <c:f>'PC SI'!$C$3:$G$3</c:f>
                <c:numCache>
                  <c:formatCode>General</c:formatCode>
                  <c:ptCount val="5"/>
                  <c:pt idx="0">
                    <c:v>8.6323493222031835E-3</c:v>
                  </c:pt>
                  <c:pt idx="1">
                    <c:v>0.1212111502976545</c:v>
                  </c:pt>
                  <c:pt idx="2">
                    <c:v>3.7493525670449515E-2</c:v>
                  </c:pt>
                  <c:pt idx="3">
                    <c:v>1.547614904128114E-2</c:v>
                  </c:pt>
                  <c:pt idx="4">
                    <c:v>4.9875310555287114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C SI'!$C$1:$G$1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PC SI'!$C$2:$G$2</c:f>
              <c:numCache>
                <c:formatCode>General</c:formatCode>
                <c:ptCount val="5"/>
                <c:pt idx="0">
                  <c:v>1</c:v>
                </c:pt>
                <c:pt idx="1">
                  <c:v>1.0274974748418759</c:v>
                </c:pt>
                <c:pt idx="2">
                  <c:v>0.96004232485019381</c:v>
                </c:pt>
                <c:pt idx="3">
                  <c:v>1.0361533883985341</c:v>
                </c:pt>
                <c:pt idx="4">
                  <c:v>1.1861215082911183</c:v>
                </c:pt>
              </c:numCache>
            </c:numRef>
          </c:val>
        </c:ser>
        <c:gapWidth val="100"/>
        <c:overlap val="-24"/>
        <c:axId val="79892864"/>
        <c:axId val="79894400"/>
      </c:barChart>
      <c:catAx>
        <c:axId val="7989286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894400"/>
        <c:crosses val="autoZero"/>
        <c:auto val="1"/>
        <c:lblAlgn val="ctr"/>
        <c:lblOffset val="100"/>
      </c:catAx>
      <c:valAx>
        <c:axId val="79894400"/>
        <c:scaling>
          <c:orientation val="minMax"/>
          <c:max val="2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892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67"/>
          <c:y val="7.3461912890367673E-2"/>
          <c:w val="0.77012891507294878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C SI'!$B$35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0070C0"/>
            </a:solidFill>
            <a:ln w="6350" cap="flat" cmpd="sng" algn="ctr">
              <a:solidFill>
                <a:srgbClr val="0070C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C SI'!$C$36:$G$36</c:f>
                <c:numCache>
                  <c:formatCode>General</c:formatCode>
                  <c:ptCount val="5"/>
                  <c:pt idx="0">
                    <c:v>3.9530178779196352E-2</c:v>
                  </c:pt>
                  <c:pt idx="1">
                    <c:v>7.4746478762880361E-2</c:v>
                  </c:pt>
                  <c:pt idx="2">
                    <c:v>2.068959810049454E-2</c:v>
                  </c:pt>
                  <c:pt idx="3">
                    <c:v>4.900353037672988E-2</c:v>
                  </c:pt>
                  <c:pt idx="4">
                    <c:v>2.6350227839782081E-2</c:v>
                  </c:pt>
                </c:numCache>
              </c:numRef>
            </c:plus>
            <c:minus>
              <c:numRef>
                <c:f>'PC SI'!$C$36:$G$36</c:f>
                <c:numCache>
                  <c:formatCode>General</c:formatCode>
                  <c:ptCount val="5"/>
                  <c:pt idx="0">
                    <c:v>3.9530178779196352E-2</c:v>
                  </c:pt>
                  <c:pt idx="1">
                    <c:v>7.4746478762880361E-2</c:v>
                  </c:pt>
                  <c:pt idx="2">
                    <c:v>2.068959810049454E-2</c:v>
                  </c:pt>
                  <c:pt idx="3">
                    <c:v>4.900353037672988E-2</c:v>
                  </c:pt>
                  <c:pt idx="4">
                    <c:v>2.6350227839782081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C SI'!$C$34:$G$34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PC SI'!$C$35:$G$35</c:f>
              <c:numCache>
                <c:formatCode>General</c:formatCode>
                <c:ptCount val="5"/>
                <c:pt idx="0">
                  <c:v>1</c:v>
                </c:pt>
                <c:pt idx="1">
                  <c:v>0.77999245895371183</c:v>
                </c:pt>
                <c:pt idx="2">
                  <c:v>0.73994698748352461</c:v>
                </c:pt>
                <c:pt idx="3">
                  <c:v>1.0484975845363205</c:v>
                </c:pt>
                <c:pt idx="4">
                  <c:v>0.87316000377058423</c:v>
                </c:pt>
              </c:numCache>
            </c:numRef>
          </c:val>
        </c:ser>
        <c:gapWidth val="100"/>
        <c:overlap val="-24"/>
        <c:axId val="79918592"/>
        <c:axId val="79920128"/>
      </c:barChart>
      <c:catAx>
        <c:axId val="79918592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920128"/>
        <c:crosses val="autoZero"/>
        <c:auto val="1"/>
        <c:lblAlgn val="ctr"/>
        <c:lblOffset val="100"/>
      </c:catAx>
      <c:valAx>
        <c:axId val="79920128"/>
        <c:scaling>
          <c:orientation val="minMax"/>
          <c:max val="2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918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75"/>
          <c:y val="7.3461912890367673E-2"/>
          <c:w val="0.77012891507294878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C SI'!$B$17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0070C0"/>
            </a:solidFill>
            <a:ln w="6350" cap="flat" cmpd="sng" algn="ctr">
              <a:solidFill>
                <a:srgbClr val="0070C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C SI'!$C$18:$G$18</c:f>
                <c:numCache>
                  <c:formatCode>General</c:formatCode>
                  <c:ptCount val="5"/>
                  <c:pt idx="0">
                    <c:v>2.0136133347510972E-2</c:v>
                  </c:pt>
                  <c:pt idx="1">
                    <c:v>2.4173134380453924E-2</c:v>
                  </c:pt>
                  <c:pt idx="2">
                    <c:v>3.5227220791967044E-2</c:v>
                  </c:pt>
                  <c:pt idx="3">
                    <c:v>1.6991297474927308E-2</c:v>
                  </c:pt>
                  <c:pt idx="4">
                    <c:v>1.531631023138689E-2</c:v>
                  </c:pt>
                </c:numCache>
              </c:numRef>
            </c:plus>
            <c:minus>
              <c:numRef>
                <c:f>'PC SI'!$C$18:$G$18</c:f>
                <c:numCache>
                  <c:formatCode>General</c:formatCode>
                  <c:ptCount val="5"/>
                  <c:pt idx="0">
                    <c:v>2.0136133347510972E-2</c:v>
                  </c:pt>
                  <c:pt idx="1">
                    <c:v>2.4173134380453924E-2</c:v>
                  </c:pt>
                  <c:pt idx="2">
                    <c:v>3.5227220791967044E-2</c:v>
                  </c:pt>
                  <c:pt idx="3">
                    <c:v>1.6991297474927308E-2</c:v>
                  </c:pt>
                  <c:pt idx="4">
                    <c:v>1.531631023138689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C SI'!$C$16:$G$16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PC SI'!$C$17:$G$17</c:f>
              <c:numCache>
                <c:formatCode>General</c:formatCode>
                <c:ptCount val="5"/>
                <c:pt idx="0">
                  <c:v>1</c:v>
                </c:pt>
                <c:pt idx="1">
                  <c:v>1.0353774608479083</c:v>
                </c:pt>
                <c:pt idx="2">
                  <c:v>1.0010397225603618</c:v>
                </c:pt>
                <c:pt idx="3">
                  <c:v>1.1040062756628659</c:v>
                </c:pt>
                <c:pt idx="4">
                  <c:v>1.2169259845325913</c:v>
                </c:pt>
              </c:numCache>
            </c:numRef>
          </c:val>
        </c:ser>
        <c:gapWidth val="100"/>
        <c:overlap val="-24"/>
        <c:axId val="79952512"/>
        <c:axId val="79966592"/>
      </c:barChart>
      <c:catAx>
        <c:axId val="79952512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966592"/>
        <c:crosses val="autoZero"/>
        <c:auto val="1"/>
        <c:lblAlgn val="ctr"/>
        <c:lblOffset val="100"/>
      </c:catAx>
      <c:valAx>
        <c:axId val="79966592"/>
        <c:scaling>
          <c:orientation val="minMax"/>
          <c:max val="2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952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92"/>
          <c:y val="7.3461912890367673E-2"/>
          <c:w val="0.77012891507294878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C SI'!$J$2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0070C0"/>
            </a:solidFill>
            <a:ln w="6350" cap="flat" cmpd="sng" algn="ctr">
              <a:solidFill>
                <a:srgbClr val="0070C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C SI'!$K$3:$N$3</c:f>
                <c:numCache>
                  <c:formatCode>General</c:formatCode>
                  <c:ptCount val="4"/>
                  <c:pt idx="0">
                    <c:v>4.2712925852184606E-2</c:v>
                  </c:pt>
                  <c:pt idx="1">
                    <c:v>7.0272505969086784E-3</c:v>
                  </c:pt>
                  <c:pt idx="2">
                    <c:v>4.5893800002804984E-2</c:v>
                  </c:pt>
                  <c:pt idx="3">
                    <c:v>5.7282713169007696E-2</c:v>
                  </c:pt>
                </c:numCache>
              </c:numRef>
            </c:plus>
            <c:minus>
              <c:numRef>
                <c:f>'PC SI'!$K$3:$N$3</c:f>
                <c:numCache>
                  <c:formatCode>General</c:formatCode>
                  <c:ptCount val="4"/>
                  <c:pt idx="0">
                    <c:v>4.2712925852184606E-2</c:v>
                  </c:pt>
                  <c:pt idx="1">
                    <c:v>7.0272505969086784E-3</c:v>
                  </c:pt>
                  <c:pt idx="2">
                    <c:v>4.5893800002804984E-2</c:v>
                  </c:pt>
                  <c:pt idx="3">
                    <c:v>5.7282713169007696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C SI'!$K$1:$N$1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PC SI'!$K$2:$N$2</c:f>
              <c:numCache>
                <c:formatCode>General</c:formatCode>
                <c:ptCount val="4"/>
                <c:pt idx="0">
                  <c:v>1</c:v>
                </c:pt>
                <c:pt idx="1">
                  <c:v>0.8263181130914834</c:v>
                </c:pt>
                <c:pt idx="2">
                  <c:v>0.8583609579653606</c:v>
                </c:pt>
                <c:pt idx="3">
                  <c:v>1.039818515638065</c:v>
                </c:pt>
              </c:numCache>
            </c:numRef>
          </c:val>
        </c:ser>
        <c:gapWidth val="100"/>
        <c:overlap val="-24"/>
        <c:axId val="79990784"/>
        <c:axId val="79992320"/>
      </c:barChart>
      <c:catAx>
        <c:axId val="7999078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992320"/>
        <c:crosses val="autoZero"/>
        <c:auto val="1"/>
        <c:lblAlgn val="ctr"/>
        <c:lblOffset val="100"/>
      </c:catAx>
      <c:valAx>
        <c:axId val="79992320"/>
        <c:scaling>
          <c:orientation val="minMax"/>
          <c:max val="2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9907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81"/>
          <c:y val="7.3461912890367673E-2"/>
          <c:w val="0.77012891507294878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C SI'!$J$17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0070C0"/>
            </a:solidFill>
            <a:ln w="6350" cap="flat" cmpd="sng" algn="ctr">
              <a:solidFill>
                <a:srgbClr val="0070C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C SI'!$K$18:$N$18</c:f>
                <c:numCache>
                  <c:formatCode>General</c:formatCode>
                  <c:ptCount val="4"/>
                  <c:pt idx="0">
                    <c:v>2.5588828531304248E-2</c:v>
                  </c:pt>
                  <c:pt idx="1">
                    <c:v>3.5820928568151882E-2</c:v>
                  </c:pt>
                  <c:pt idx="2">
                    <c:v>0.25331312624281965</c:v>
                  </c:pt>
                  <c:pt idx="3">
                    <c:v>1.6995060333251755E-2</c:v>
                  </c:pt>
                </c:numCache>
              </c:numRef>
            </c:plus>
            <c:minus>
              <c:numRef>
                <c:f>'PC SI'!$K$18:$N$18</c:f>
                <c:numCache>
                  <c:formatCode>General</c:formatCode>
                  <c:ptCount val="4"/>
                  <c:pt idx="0">
                    <c:v>2.5588828531304248E-2</c:v>
                  </c:pt>
                  <c:pt idx="1">
                    <c:v>3.5820928568151882E-2</c:v>
                  </c:pt>
                  <c:pt idx="2">
                    <c:v>0.25331312624281965</c:v>
                  </c:pt>
                  <c:pt idx="3">
                    <c:v>1.6995060333251755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C SI'!$K$16:$N$16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PC SI'!$K$17:$N$17</c:f>
              <c:numCache>
                <c:formatCode>General</c:formatCode>
                <c:ptCount val="4"/>
                <c:pt idx="0">
                  <c:v>1</c:v>
                </c:pt>
                <c:pt idx="1">
                  <c:v>0.78281007549123971</c:v>
                </c:pt>
                <c:pt idx="2">
                  <c:v>0.84886856012020362</c:v>
                </c:pt>
                <c:pt idx="3">
                  <c:v>1.0651513481202093</c:v>
                </c:pt>
              </c:numCache>
            </c:numRef>
          </c:val>
        </c:ser>
        <c:gapWidth val="100"/>
        <c:overlap val="-24"/>
        <c:axId val="80090240"/>
        <c:axId val="80091776"/>
      </c:barChart>
      <c:catAx>
        <c:axId val="8009024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091776"/>
        <c:crosses val="autoZero"/>
        <c:auto val="1"/>
        <c:lblAlgn val="ctr"/>
        <c:lblOffset val="100"/>
      </c:catAx>
      <c:valAx>
        <c:axId val="80091776"/>
        <c:scaling>
          <c:orientation val="minMax"/>
          <c:max val="2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0902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61"/>
          <c:y val="7.3461912890367673E-2"/>
          <c:w val="0.77012891507294878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C SI'!$J$35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0070C0"/>
            </a:solidFill>
            <a:ln w="6350" cap="flat" cmpd="sng" algn="ctr">
              <a:solidFill>
                <a:srgbClr val="0070C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C SI'!$K$36:$O$36</c:f>
                <c:numCache>
                  <c:formatCode>General</c:formatCode>
                  <c:ptCount val="5"/>
                  <c:pt idx="0">
                    <c:v>2.5862601801903619E-2</c:v>
                  </c:pt>
                  <c:pt idx="1">
                    <c:v>9.2586826613238429E-2</c:v>
                  </c:pt>
                  <c:pt idx="2">
                    <c:v>8.6493342998876732E-2</c:v>
                  </c:pt>
                  <c:pt idx="3">
                    <c:v>1.8623685985539901E-2</c:v>
                  </c:pt>
                  <c:pt idx="4">
                    <c:v>9.2888842747629971E-2</c:v>
                  </c:pt>
                </c:numCache>
              </c:numRef>
            </c:plus>
            <c:minus>
              <c:numRef>
                <c:f>'PC SI'!$K$36:$O$36</c:f>
                <c:numCache>
                  <c:formatCode>General</c:formatCode>
                  <c:ptCount val="5"/>
                  <c:pt idx="0">
                    <c:v>2.5862601801903619E-2</c:v>
                  </c:pt>
                  <c:pt idx="1">
                    <c:v>9.2586826613238429E-2</c:v>
                  </c:pt>
                  <c:pt idx="2">
                    <c:v>8.6493342998876732E-2</c:v>
                  </c:pt>
                  <c:pt idx="3">
                    <c:v>1.8623685985539901E-2</c:v>
                  </c:pt>
                  <c:pt idx="4">
                    <c:v>9.2888842747629971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C SI'!$K$34:$O$34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PC SI'!$K$35:$O$35</c:f>
              <c:numCache>
                <c:formatCode>General</c:formatCode>
                <c:ptCount val="5"/>
                <c:pt idx="0">
                  <c:v>1.0000000000000002</c:v>
                </c:pt>
                <c:pt idx="1">
                  <c:v>1.0840086839115211</c:v>
                </c:pt>
                <c:pt idx="2">
                  <c:v>1.2205749733260707</c:v>
                </c:pt>
                <c:pt idx="3">
                  <c:v>1.2236132063837859</c:v>
                </c:pt>
                <c:pt idx="4">
                  <c:v>1.3141635188059322</c:v>
                </c:pt>
              </c:numCache>
            </c:numRef>
          </c:val>
        </c:ser>
        <c:gapWidth val="100"/>
        <c:overlap val="-24"/>
        <c:axId val="80132352"/>
        <c:axId val="80138240"/>
      </c:barChart>
      <c:catAx>
        <c:axId val="80132352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138240"/>
        <c:crosses val="autoZero"/>
        <c:auto val="1"/>
        <c:lblAlgn val="ctr"/>
        <c:lblOffset val="100"/>
      </c:catAx>
      <c:valAx>
        <c:axId val="80138240"/>
        <c:scaling>
          <c:orientation val="minMax"/>
          <c:max val="2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1323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A15945-6199-4706-9261-44B47929DB86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94DFB6-8908-4C5C-81EA-23F4DA78596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20663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5: 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tty acid s</a:t>
            </a:r>
            <a:r>
              <a:rPr lang="en-US" b="0" dirty="0" smtClean="0"/>
              <a:t>aturation indices </a:t>
            </a:r>
            <a:r>
              <a:rPr lang="en-US" dirty="0" smtClean="0"/>
              <a:t>(FA-SI) of </a:t>
            </a:r>
            <a:r>
              <a:rPr lang="en-US" sz="1200" b="0" dirty="0" err="1" smtClean="0"/>
              <a:t>phosphatidylcholine</a:t>
            </a:r>
            <a:r>
              <a:rPr lang="en-US" dirty="0" smtClean="0"/>
              <a:t> (PC) </a:t>
            </a:r>
            <a:r>
              <a:rPr lang="en-US" smtClean="0"/>
              <a:t>in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a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CL22 (Leukemia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b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G1 (Leukemia)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c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U812 (Leukemia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d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W480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Colon cancer)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e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W620 (Colon cancer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f)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549 (Lung Cancer)</a:t>
            </a:r>
            <a:r>
              <a:rPr lang="en-US" sz="1200" u="none" strike="noStrike" baseline="0" smtClean="0">
                <a:effectLst/>
              </a:rPr>
              <a:t> </a:t>
            </a:r>
            <a:r>
              <a:rPr lang="en-US" sz="1200" u="none" strike="noStrike" baseline="0" dirty="0" smtClean="0">
                <a:effectLst/>
              </a:rPr>
              <a:t>cell lines under Nor, LPDS, LS, </a:t>
            </a:r>
            <a:r>
              <a:rPr lang="en-US" sz="1200" u="none" strike="noStrike" baseline="0" dirty="0" err="1" smtClean="0">
                <a:effectLst/>
              </a:rPr>
              <a:t>Hyp</a:t>
            </a:r>
            <a:r>
              <a:rPr lang="en-US" sz="1200" u="none" strike="noStrike" baseline="0" dirty="0" smtClean="0">
                <a:effectLst/>
              </a:rPr>
              <a:t> or </a:t>
            </a:r>
            <a:r>
              <a:rPr lang="en-US" sz="1200" u="none" strike="noStrike" baseline="0" dirty="0" err="1" smtClean="0">
                <a:effectLst/>
              </a:rPr>
              <a:t>Hyp+LS</a:t>
            </a:r>
            <a:r>
              <a:rPr lang="en-US" sz="1200" u="none" strike="noStrike" baseline="0" dirty="0" smtClean="0">
                <a:effectLst/>
              </a:rPr>
              <a:t> conditions.</a:t>
            </a:r>
            <a:endParaRPr lang="en-US" b="1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94DFB6-8908-4C5C-81EA-23F4DA78596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906731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45721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41710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05683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56111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98847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6255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4732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61549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39769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08833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99800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2701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/>
          <p:cNvSpPr txBox="1"/>
          <p:nvPr/>
        </p:nvSpPr>
        <p:spPr>
          <a:xfrm>
            <a:off x="3491862" y="1105709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G1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>
            <a:off x="4939245" y="1092739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U812</a:t>
            </a:r>
            <a:endParaRPr lang="en-US" sz="1000" dirty="0"/>
          </a:p>
        </p:txBody>
      </p:sp>
      <p:sp>
        <p:nvSpPr>
          <p:cNvPr id="47" name="TextBox 46"/>
          <p:cNvSpPr txBox="1"/>
          <p:nvPr/>
        </p:nvSpPr>
        <p:spPr>
          <a:xfrm>
            <a:off x="1815462" y="1105709"/>
            <a:ext cx="5068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CL22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>
            <a:off x="3532026" y="2795079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W620</a:t>
            </a:r>
            <a:endParaRPr lang="en-US" sz="1000" dirty="0"/>
          </a:p>
        </p:txBody>
      </p:sp>
      <p:sp>
        <p:nvSpPr>
          <p:cNvPr id="49" name="TextBox 48"/>
          <p:cNvSpPr txBox="1"/>
          <p:nvPr/>
        </p:nvSpPr>
        <p:spPr>
          <a:xfrm>
            <a:off x="5054750" y="2795079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A549</a:t>
            </a:r>
            <a:endParaRPr lang="en-US" sz="1000" dirty="0"/>
          </a:p>
        </p:txBody>
      </p:sp>
      <p:sp>
        <p:nvSpPr>
          <p:cNvPr id="50" name="TextBox 49"/>
          <p:cNvSpPr txBox="1"/>
          <p:nvPr/>
        </p:nvSpPr>
        <p:spPr>
          <a:xfrm>
            <a:off x="1855626" y="2795079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W480</a:t>
            </a:r>
            <a:endParaRPr lang="en-US" sz="1000" dirty="0"/>
          </a:p>
        </p:txBody>
      </p:sp>
      <p:graphicFrame>
        <p:nvGraphicFramePr>
          <p:cNvPr id="54" name="Chart 5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4205191400"/>
              </p:ext>
            </p:extLst>
          </p:nvPr>
        </p:nvGraphicFramePr>
        <p:xfrm>
          <a:off x="2895600" y="13716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5" name="Chart 54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3043223689"/>
              </p:ext>
            </p:extLst>
          </p:nvPr>
        </p:nvGraphicFramePr>
        <p:xfrm>
          <a:off x="1371600" y="13716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6" name="Chart 55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3621616561"/>
              </p:ext>
            </p:extLst>
          </p:nvPr>
        </p:nvGraphicFramePr>
        <p:xfrm>
          <a:off x="4495800" y="13716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7" name="Chart 56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486055524"/>
              </p:ext>
            </p:extLst>
          </p:nvPr>
        </p:nvGraphicFramePr>
        <p:xfrm>
          <a:off x="1371600" y="28194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8" name="Chart 57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63343400"/>
              </p:ext>
            </p:extLst>
          </p:nvPr>
        </p:nvGraphicFramePr>
        <p:xfrm>
          <a:off x="2936661" y="2823654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9" name="Chart 58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4003188183"/>
              </p:ext>
            </p:extLst>
          </p:nvPr>
        </p:nvGraphicFramePr>
        <p:xfrm>
          <a:off x="4495800" y="28194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60" name="TextBox 59"/>
          <p:cNvSpPr txBox="1"/>
          <p:nvPr/>
        </p:nvSpPr>
        <p:spPr>
          <a:xfrm rot="16200000">
            <a:off x="799763" y="1649561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C 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228600" y="228600"/>
            <a:ext cx="1345240" cy="207749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sz="75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Supplementary Figure S4</a:t>
            </a:r>
            <a:endParaRPr lang="en-US" sz="7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2399963" y="1649561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C 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4000163" y="1649561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C 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865040" y="3097361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C 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2399963" y="3097361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C 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4000163" y="3085763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C 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</p:spTree>
    <p:extLst>
      <p:ext uri="{BB962C8B-B14F-4D97-AF65-F5344CB8AC3E}">
        <p14:creationId xmlns="" xmlns:p14="http://schemas.microsoft.com/office/powerpoint/2010/main" val="10885720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1</TotalTime>
  <Words>128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Nousheen Zaidi</dc:creator>
  <cp:lastModifiedBy>Rida Rashid</cp:lastModifiedBy>
  <cp:revision>244</cp:revision>
  <dcterms:created xsi:type="dcterms:W3CDTF">2017-10-04T17:41:58Z</dcterms:created>
  <dcterms:modified xsi:type="dcterms:W3CDTF">2019-04-06T22:09:22Z</dcterms:modified>
</cp:coreProperties>
</file>